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61" r:id="rId4"/>
    <p:sldId id="260" r:id="rId5"/>
    <p:sldId id="262" r:id="rId6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195" autoAdjust="0"/>
    <p:restoredTop sz="94660"/>
  </p:normalViewPr>
  <p:slideViewPr>
    <p:cSldViewPr snapToGrid="0">
      <p:cViewPr>
        <p:scale>
          <a:sx n="75" d="100"/>
          <a:sy n="75" d="100"/>
        </p:scale>
        <p:origin x="2501" y="-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6141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92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0035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522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4365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07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587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152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171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9682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345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90C48-0C3D-4C49-89B3-027FB4F35D77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F1BC2-E4D9-4634-9389-E94F28F854A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0641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png"/><Relationship Id="rId2" Type="http://schemas.openxmlformats.org/officeDocument/2006/relationships/image" Target="../media/image6.png"/><Relationship Id="rId16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1578" y="1958725"/>
            <a:ext cx="4490207" cy="336765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376602" y="5714204"/>
            <a:ext cx="41496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. Quality control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e proteome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494031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464" y="1775769"/>
            <a:ext cx="4287795" cy="3215846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351202" y="5414484"/>
            <a:ext cx="41496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The annotations of total proteins.</a:t>
            </a:r>
          </a:p>
        </p:txBody>
      </p:sp>
    </p:spTree>
    <p:extLst>
      <p:ext uri="{BB962C8B-B14F-4D97-AF65-F5344CB8AC3E}">
        <p14:creationId xmlns:p14="http://schemas.microsoft.com/office/powerpoint/2010/main" val="42631625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/>
          <a:srcRect l="19955" t="8709" r="17804" b="2428"/>
          <a:stretch/>
        </p:blipFill>
        <p:spPr>
          <a:xfrm>
            <a:off x="1557287" y="2208998"/>
            <a:ext cx="3946358" cy="2269957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1557287" y="4713655"/>
            <a:ext cx="4038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zh-CN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ven 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bgroups of lipids </a:t>
            </a:r>
            <a:r>
              <a:rPr lang="zh-CN" alt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zh-CN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etected using lipidomics.</a:t>
            </a:r>
          </a:p>
        </p:txBody>
      </p:sp>
    </p:spTree>
    <p:extLst>
      <p:ext uri="{BB962C8B-B14F-4D97-AF65-F5344CB8AC3E}">
        <p14:creationId xmlns:p14="http://schemas.microsoft.com/office/powerpoint/2010/main" val="23701387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2167889" y="1729818"/>
            <a:ext cx="2160000" cy="1972073"/>
            <a:chOff x="3206496" y="4801592"/>
            <a:chExt cx="2160000" cy="1972073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/>
            <a:srcRect l="1129"/>
            <a:stretch/>
          </p:blipFill>
          <p:spPr>
            <a:xfrm>
              <a:off x="3206496" y="4801592"/>
              <a:ext cx="2160000" cy="1380309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06496" y="6241456"/>
              <a:ext cx="2160000" cy="532209"/>
            </a:xfrm>
            <a:prstGeom prst="rect">
              <a:avLst/>
            </a:prstGeom>
          </p:spPr>
        </p:pic>
      </p:grpSp>
      <p:sp>
        <p:nvSpPr>
          <p:cNvPr id="6" name="文本框 5"/>
          <p:cNvSpPr txBox="1"/>
          <p:nvPr/>
        </p:nvSpPr>
        <p:spPr>
          <a:xfrm>
            <a:off x="1479218" y="4176996"/>
            <a:ext cx="41496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. The lipid species of DELs in two comparisons.</a:t>
            </a:r>
          </a:p>
        </p:txBody>
      </p:sp>
    </p:spTree>
    <p:extLst>
      <p:ext uri="{BB962C8B-B14F-4D97-AF65-F5344CB8AC3E}">
        <p14:creationId xmlns:p14="http://schemas.microsoft.com/office/powerpoint/2010/main" val="1601859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29110" y="6805613"/>
            <a:ext cx="5235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5. The ion characteristic fragments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chromatogram for eight lipid species.</a:t>
            </a:r>
          </a:p>
        </p:txBody>
      </p:sp>
      <p:sp>
        <p:nvSpPr>
          <p:cNvPr id="4" name="矩形 3"/>
          <p:cNvSpPr/>
          <p:nvPr/>
        </p:nvSpPr>
        <p:spPr>
          <a:xfrm>
            <a:off x="1286508" y="409886"/>
            <a:ext cx="1053233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DGDG(18:4_14:1)+H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1262376" y="1960866"/>
            <a:ext cx="976549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GDG(18:0_11:2)-H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1230315" y="5104231"/>
            <a:ext cx="904415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A(19:1_18:3)-H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230315" y="3594042"/>
            <a:ext cx="1040670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A(19:0_18:2)-H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4258783" y="427720"/>
            <a:ext cx="1106755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MGDG(18:3_18:3)+HCOO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4368464" y="1952614"/>
            <a:ext cx="805029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A(18:0_16:0)-H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4353723" y="3576567"/>
            <a:ext cx="1011815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A(19:1_16:0)-H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4427956" y="5098757"/>
            <a:ext cx="937582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PA(20:1_18:1)-H </a:t>
            </a:r>
            <a:endParaRPr lang="zh-CN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421" y="639380"/>
            <a:ext cx="1440000" cy="108000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421" y="639380"/>
            <a:ext cx="1440000" cy="1080000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1598" y="670383"/>
            <a:ext cx="1440000" cy="108000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8775" y="670383"/>
            <a:ext cx="1440000" cy="108000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421" y="2203353"/>
            <a:ext cx="1440000" cy="108000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421" y="2186934"/>
            <a:ext cx="1440000" cy="108000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7114" y="2186934"/>
            <a:ext cx="1440000" cy="1080000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9180" y="2186934"/>
            <a:ext cx="1440000" cy="1080000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421" y="3843240"/>
            <a:ext cx="1440000" cy="1080000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353" y="3821124"/>
            <a:ext cx="1440000" cy="1080000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8775" y="3795983"/>
            <a:ext cx="1440000" cy="1080000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7114" y="3822448"/>
            <a:ext cx="1440000" cy="1080000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3353" y="5280085"/>
            <a:ext cx="1440000" cy="1080000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001" y="5280085"/>
            <a:ext cx="1440000" cy="1080000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51064" y="5288897"/>
            <a:ext cx="1440000" cy="1080000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8775" y="5312699"/>
            <a:ext cx="14400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4035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2</TotalTime>
  <Words>80</Words>
  <Application>Microsoft Office PowerPoint</Application>
  <PresentationFormat>A4 纸张(210x297 毫米)</PresentationFormat>
  <Paragraphs>13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o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orosoft</dc:creator>
  <cp:lastModifiedBy>joe</cp:lastModifiedBy>
  <cp:revision>30</cp:revision>
  <dcterms:created xsi:type="dcterms:W3CDTF">2021-04-02T07:19:11Z</dcterms:created>
  <dcterms:modified xsi:type="dcterms:W3CDTF">2022-10-19T01:23:27Z</dcterms:modified>
</cp:coreProperties>
</file>